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8002250" cy="18002250"/>
  <p:notesSz cx="6858000" cy="9144000"/>
  <p:custDataLst>
    <p:tags r:id="rId3"/>
  </p:custDataLst>
  <p:defaultTextStyle>
    <a:defPPr>
      <a:defRPr lang="da-DK"/>
    </a:defPPr>
    <a:lvl1pPr marL="0" algn="l" defTabSz="2057400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1pPr>
    <a:lvl2pPr marL="1028700" algn="l" defTabSz="2057400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2pPr>
    <a:lvl3pPr marL="2057400" algn="l" defTabSz="2057400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3pPr>
    <a:lvl4pPr marL="3086100" algn="l" defTabSz="2057400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4pPr>
    <a:lvl5pPr marL="4114800" algn="l" defTabSz="2057400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5pPr>
    <a:lvl6pPr marL="5143500" algn="l" defTabSz="2057400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6pPr>
    <a:lvl7pPr marL="6172200" algn="l" defTabSz="2057400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7pPr>
    <a:lvl8pPr marL="7200900" algn="l" defTabSz="2057400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8pPr>
    <a:lvl9pPr marL="8229600" algn="l" defTabSz="2057400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33" d="100"/>
          <a:sy n="33" d="100"/>
        </p:scale>
        <p:origin x="-1934" y="62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350169" y="5592367"/>
            <a:ext cx="15301913" cy="3858816"/>
          </a:xfrm>
        </p:spPr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2700338" y="10201275"/>
            <a:ext cx="12601575" cy="460057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0861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4114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5143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6172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7200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8229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77D4E-C74E-41B7-8EC3-42E969CCBCCC}" type="datetimeFigureOut">
              <a:rPr lang="da-DK" smtClean="0"/>
              <a:t>29-01-2018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50C9-57FD-4BEF-A576-945C40A70B5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135594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77D4E-C74E-41B7-8EC3-42E969CCBCCC}" type="datetimeFigureOut">
              <a:rPr lang="da-DK" smtClean="0"/>
              <a:t>29-01-2018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50C9-57FD-4BEF-A576-945C40A70B5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268641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13051631" y="720926"/>
            <a:ext cx="4050506" cy="15360253"/>
          </a:xfrm>
        </p:spPr>
        <p:txBody>
          <a:bodyPr vert="eaVert"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900113" y="720926"/>
            <a:ext cx="11851481" cy="15360253"/>
          </a:xfrm>
        </p:spPr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77D4E-C74E-41B7-8EC3-42E969CCBCCC}" type="datetimeFigureOut">
              <a:rPr lang="da-DK" smtClean="0"/>
              <a:t>29-01-2018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50C9-57FD-4BEF-A576-945C40A70B5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3586558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77D4E-C74E-41B7-8EC3-42E969CCBCCC}" type="datetimeFigureOut">
              <a:rPr lang="da-DK" smtClean="0"/>
              <a:t>29-01-2018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50C9-57FD-4BEF-A576-945C40A70B5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296516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422053" y="11568114"/>
            <a:ext cx="15301913" cy="3575447"/>
          </a:xfrm>
        </p:spPr>
        <p:txBody>
          <a:bodyPr anchor="t"/>
          <a:lstStyle>
            <a:lvl1pPr algn="l">
              <a:defRPr sz="9000" b="1" cap="all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1422053" y="7630123"/>
            <a:ext cx="15301913" cy="3937991"/>
          </a:xfrm>
        </p:spPr>
        <p:txBody>
          <a:bodyPr anchor="b"/>
          <a:lstStyle>
            <a:lvl1pPr marL="0" indent="0">
              <a:buNone/>
              <a:defRPr sz="4500">
                <a:solidFill>
                  <a:schemeClr val="tx1">
                    <a:tint val="75000"/>
                  </a:schemeClr>
                </a:solidFill>
              </a:defRPr>
            </a:lvl1pPr>
            <a:lvl2pPr marL="1028700" indent="0">
              <a:buNone/>
              <a:defRPr sz="4100">
                <a:solidFill>
                  <a:schemeClr val="tx1">
                    <a:tint val="75000"/>
                  </a:schemeClr>
                </a:solidFill>
              </a:defRPr>
            </a:lvl2pPr>
            <a:lvl3pPr marL="20574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3pPr>
            <a:lvl4pPr marL="30861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41148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51435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6172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72009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82296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77D4E-C74E-41B7-8EC3-42E969CCBCCC}" type="datetimeFigureOut">
              <a:rPr lang="da-DK" smtClean="0"/>
              <a:t>29-01-2018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50C9-57FD-4BEF-A576-945C40A70B5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737131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900112" y="4200526"/>
            <a:ext cx="7950994" cy="11880653"/>
          </a:xfrm>
        </p:spPr>
        <p:txBody>
          <a:bodyPr/>
          <a:lstStyle>
            <a:lvl1pPr>
              <a:defRPr sz="6300"/>
            </a:lvl1pPr>
            <a:lvl2pPr>
              <a:defRPr sz="5400"/>
            </a:lvl2pPr>
            <a:lvl3pPr>
              <a:defRPr sz="4500"/>
            </a:lvl3pPr>
            <a:lvl4pPr>
              <a:defRPr sz="4100"/>
            </a:lvl4pPr>
            <a:lvl5pPr>
              <a:defRPr sz="4100"/>
            </a:lvl5pPr>
            <a:lvl6pPr>
              <a:defRPr sz="4100"/>
            </a:lvl6pPr>
            <a:lvl7pPr>
              <a:defRPr sz="4100"/>
            </a:lvl7pPr>
            <a:lvl8pPr>
              <a:defRPr sz="4100"/>
            </a:lvl8pPr>
            <a:lvl9pPr>
              <a:defRPr sz="41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9151144" y="4200526"/>
            <a:ext cx="7950994" cy="11880653"/>
          </a:xfrm>
        </p:spPr>
        <p:txBody>
          <a:bodyPr/>
          <a:lstStyle>
            <a:lvl1pPr>
              <a:defRPr sz="6300"/>
            </a:lvl1pPr>
            <a:lvl2pPr>
              <a:defRPr sz="5400"/>
            </a:lvl2pPr>
            <a:lvl3pPr>
              <a:defRPr sz="4500"/>
            </a:lvl3pPr>
            <a:lvl4pPr>
              <a:defRPr sz="4100"/>
            </a:lvl4pPr>
            <a:lvl5pPr>
              <a:defRPr sz="4100"/>
            </a:lvl5pPr>
            <a:lvl6pPr>
              <a:defRPr sz="4100"/>
            </a:lvl6pPr>
            <a:lvl7pPr>
              <a:defRPr sz="4100"/>
            </a:lvl7pPr>
            <a:lvl8pPr>
              <a:defRPr sz="4100"/>
            </a:lvl8pPr>
            <a:lvl9pPr>
              <a:defRPr sz="41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77D4E-C74E-41B7-8EC3-42E969CCBCCC}" type="datetimeFigureOut">
              <a:rPr lang="da-DK" smtClean="0"/>
              <a:t>29-01-2018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50C9-57FD-4BEF-A576-945C40A70B5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182701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900113" y="4029672"/>
            <a:ext cx="7954120" cy="1679375"/>
          </a:xfrm>
        </p:spPr>
        <p:txBody>
          <a:bodyPr anchor="b"/>
          <a:lstStyle>
            <a:lvl1pPr marL="0" indent="0">
              <a:buNone/>
              <a:defRPr sz="5400" b="1"/>
            </a:lvl1pPr>
            <a:lvl2pPr marL="1028700" indent="0">
              <a:buNone/>
              <a:defRPr sz="4500" b="1"/>
            </a:lvl2pPr>
            <a:lvl3pPr marL="2057400" indent="0">
              <a:buNone/>
              <a:defRPr sz="4100" b="1"/>
            </a:lvl3pPr>
            <a:lvl4pPr marL="3086100" indent="0">
              <a:buNone/>
              <a:defRPr sz="3600" b="1"/>
            </a:lvl4pPr>
            <a:lvl5pPr marL="4114800" indent="0">
              <a:buNone/>
              <a:defRPr sz="3600" b="1"/>
            </a:lvl5pPr>
            <a:lvl6pPr marL="5143500" indent="0">
              <a:buNone/>
              <a:defRPr sz="3600" b="1"/>
            </a:lvl6pPr>
            <a:lvl7pPr marL="6172200" indent="0">
              <a:buNone/>
              <a:defRPr sz="3600" b="1"/>
            </a:lvl7pPr>
            <a:lvl8pPr marL="7200900" indent="0">
              <a:buNone/>
              <a:defRPr sz="3600" b="1"/>
            </a:lvl8pPr>
            <a:lvl9pPr marL="8229600" indent="0">
              <a:buNone/>
              <a:defRPr sz="3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900113" y="5709047"/>
            <a:ext cx="7954120" cy="10372131"/>
          </a:xfrm>
        </p:spPr>
        <p:txBody>
          <a:bodyPr/>
          <a:lstStyle>
            <a:lvl1pPr>
              <a:defRPr sz="5400"/>
            </a:lvl1pPr>
            <a:lvl2pPr>
              <a:defRPr sz="4500"/>
            </a:lvl2pPr>
            <a:lvl3pPr>
              <a:defRPr sz="41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9144894" y="4029672"/>
            <a:ext cx="7957245" cy="1679375"/>
          </a:xfrm>
        </p:spPr>
        <p:txBody>
          <a:bodyPr anchor="b"/>
          <a:lstStyle>
            <a:lvl1pPr marL="0" indent="0">
              <a:buNone/>
              <a:defRPr sz="5400" b="1"/>
            </a:lvl1pPr>
            <a:lvl2pPr marL="1028700" indent="0">
              <a:buNone/>
              <a:defRPr sz="4500" b="1"/>
            </a:lvl2pPr>
            <a:lvl3pPr marL="2057400" indent="0">
              <a:buNone/>
              <a:defRPr sz="4100" b="1"/>
            </a:lvl3pPr>
            <a:lvl4pPr marL="3086100" indent="0">
              <a:buNone/>
              <a:defRPr sz="3600" b="1"/>
            </a:lvl4pPr>
            <a:lvl5pPr marL="4114800" indent="0">
              <a:buNone/>
              <a:defRPr sz="3600" b="1"/>
            </a:lvl5pPr>
            <a:lvl6pPr marL="5143500" indent="0">
              <a:buNone/>
              <a:defRPr sz="3600" b="1"/>
            </a:lvl6pPr>
            <a:lvl7pPr marL="6172200" indent="0">
              <a:buNone/>
              <a:defRPr sz="3600" b="1"/>
            </a:lvl7pPr>
            <a:lvl8pPr marL="7200900" indent="0">
              <a:buNone/>
              <a:defRPr sz="3600" b="1"/>
            </a:lvl8pPr>
            <a:lvl9pPr marL="8229600" indent="0">
              <a:buNone/>
              <a:defRPr sz="3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9144894" y="5709047"/>
            <a:ext cx="7957245" cy="10372131"/>
          </a:xfrm>
        </p:spPr>
        <p:txBody>
          <a:bodyPr/>
          <a:lstStyle>
            <a:lvl1pPr>
              <a:defRPr sz="5400"/>
            </a:lvl1pPr>
            <a:lvl2pPr>
              <a:defRPr sz="4500"/>
            </a:lvl2pPr>
            <a:lvl3pPr>
              <a:defRPr sz="41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7" name="Pladsholder til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77D4E-C74E-41B7-8EC3-42E969CCBCCC}" type="datetimeFigureOut">
              <a:rPr lang="da-DK" smtClean="0"/>
              <a:t>29-01-2018</a:t>
            </a:fld>
            <a:endParaRPr lang="da-DK"/>
          </a:p>
        </p:txBody>
      </p:sp>
      <p:sp>
        <p:nvSpPr>
          <p:cNvPr id="8" name="Pladsholder til sidefod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dias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50C9-57FD-4BEF-A576-945C40A70B5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1258084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77D4E-C74E-41B7-8EC3-42E969CCBCCC}" type="datetimeFigureOut">
              <a:rPr lang="da-DK" smtClean="0"/>
              <a:t>29-01-2018</a:t>
            </a:fld>
            <a:endParaRPr lang="da-DK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dias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50C9-57FD-4BEF-A576-945C40A70B5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430898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77D4E-C74E-41B7-8EC3-42E969CCBCCC}" type="datetimeFigureOut">
              <a:rPr lang="da-DK" smtClean="0"/>
              <a:t>29-01-2018</a:t>
            </a:fld>
            <a:endParaRPr lang="da-DK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50C9-57FD-4BEF-A576-945C40A70B5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1783862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900114" y="716756"/>
            <a:ext cx="5922616" cy="3050381"/>
          </a:xfrm>
        </p:spPr>
        <p:txBody>
          <a:bodyPr anchor="b"/>
          <a:lstStyle>
            <a:lvl1pPr algn="l">
              <a:defRPr sz="4500" b="1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7038380" y="716757"/>
            <a:ext cx="10063758" cy="15364422"/>
          </a:xfrm>
        </p:spPr>
        <p:txBody>
          <a:bodyPr/>
          <a:lstStyle>
            <a:lvl1pPr>
              <a:defRPr sz="7200"/>
            </a:lvl1pPr>
            <a:lvl2pPr>
              <a:defRPr sz="6300"/>
            </a:lvl2pPr>
            <a:lvl3pPr>
              <a:defRPr sz="5400"/>
            </a:lvl3pPr>
            <a:lvl4pPr>
              <a:defRPr sz="4500"/>
            </a:lvl4pPr>
            <a:lvl5pPr>
              <a:defRPr sz="4500"/>
            </a:lvl5pPr>
            <a:lvl6pPr>
              <a:defRPr sz="4500"/>
            </a:lvl6pPr>
            <a:lvl7pPr>
              <a:defRPr sz="4500"/>
            </a:lvl7pPr>
            <a:lvl8pPr>
              <a:defRPr sz="4500"/>
            </a:lvl8pPr>
            <a:lvl9pPr>
              <a:defRPr sz="45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900114" y="3767139"/>
            <a:ext cx="5922616" cy="12314040"/>
          </a:xfrm>
        </p:spPr>
        <p:txBody>
          <a:bodyPr/>
          <a:lstStyle>
            <a:lvl1pPr marL="0" indent="0">
              <a:buNone/>
              <a:defRPr sz="3200"/>
            </a:lvl1pPr>
            <a:lvl2pPr marL="1028700" indent="0">
              <a:buNone/>
              <a:defRPr sz="2700"/>
            </a:lvl2pPr>
            <a:lvl3pPr marL="2057400" indent="0">
              <a:buNone/>
              <a:defRPr sz="2300"/>
            </a:lvl3pPr>
            <a:lvl4pPr marL="3086100" indent="0">
              <a:buNone/>
              <a:defRPr sz="2000"/>
            </a:lvl4pPr>
            <a:lvl5pPr marL="4114800" indent="0">
              <a:buNone/>
              <a:defRPr sz="2000"/>
            </a:lvl5pPr>
            <a:lvl6pPr marL="5143500" indent="0">
              <a:buNone/>
              <a:defRPr sz="2000"/>
            </a:lvl6pPr>
            <a:lvl7pPr marL="6172200" indent="0">
              <a:buNone/>
              <a:defRPr sz="2000"/>
            </a:lvl7pPr>
            <a:lvl8pPr marL="7200900" indent="0">
              <a:buNone/>
              <a:defRPr sz="2000"/>
            </a:lvl8pPr>
            <a:lvl9pPr marL="8229600" indent="0">
              <a:buNone/>
              <a:defRPr sz="20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77D4E-C74E-41B7-8EC3-42E969CCBCCC}" type="datetimeFigureOut">
              <a:rPr lang="da-DK" smtClean="0"/>
              <a:t>29-01-2018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50C9-57FD-4BEF-A576-945C40A70B5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5618603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528567" y="12601575"/>
            <a:ext cx="10801350" cy="1487687"/>
          </a:xfrm>
        </p:spPr>
        <p:txBody>
          <a:bodyPr anchor="b"/>
          <a:lstStyle>
            <a:lvl1pPr algn="l">
              <a:defRPr sz="4500" b="1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3528567" y="1608534"/>
            <a:ext cx="10801350" cy="10801350"/>
          </a:xfrm>
        </p:spPr>
        <p:txBody>
          <a:bodyPr/>
          <a:lstStyle>
            <a:lvl1pPr marL="0" indent="0">
              <a:buNone/>
              <a:defRPr sz="7200"/>
            </a:lvl1pPr>
            <a:lvl2pPr marL="1028700" indent="0">
              <a:buNone/>
              <a:defRPr sz="6300"/>
            </a:lvl2pPr>
            <a:lvl3pPr marL="2057400" indent="0">
              <a:buNone/>
              <a:defRPr sz="5400"/>
            </a:lvl3pPr>
            <a:lvl4pPr marL="3086100" indent="0">
              <a:buNone/>
              <a:defRPr sz="4500"/>
            </a:lvl4pPr>
            <a:lvl5pPr marL="4114800" indent="0">
              <a:buNone/>
              <a:defRPr sz="4500"/>
            </a:lvl5pPr>
            <a:lvl6pPr marL="5143500" indent="0">
              <a:buNone/>
              <a:defRPr sz="4500"/>
            </a:lvl6pPr>
            <a:lvl7pPr marL="6172200" indent="0">
              <a:buNone/>
              <a:defRPr sz="4500"/>
            </a:lvl7pPr>
            <a:lvl8pPr marL="7200900" indent="0">
              <a:buNone/>
              <a:defRPr sz="4500"/>
            </a:lvl8pPr>
            <a:lvl9pPr marL="8229600" indent="0">
              <a:buNone/>
              <a:defRPr sz="4500"/>
            </a:lvl9pPr>
          </a:lstStyle>
          <a:p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3528567" y="14089262"/>
            <a:ext cx="10801350" cy="2112763"/>
          </a:xfrm>
        </p:spPr>
        <p:txBody>
          <a:bodyPr/>
          <a:lstStyle>
            <a:lvl1pPr marL="0" indent="0">
              <a:buNone/>
              <a:defRPr sz="3200"/>
            </a:lvl1pPr>
            <a:lvl2pPr marL="1028700" indent="0">
              <a:buNone/>
              <a:defRPr sz="2700"/>
            </a:lvl2pPr>
            <a:lvl3pPr marL="2057400" indent="0">
              <a:buNone/>
              <a:defRPr sz="2300"/>
            </a:lvl3pPr>
            <a:lvl4pPr marL="3086100" indent="0">
              <a:buNone/>
              <a:defRPr sz="2000"/>
            </a:lvl4pPr>
            <a:lvl5pPr marL="4114800" indent="0">
              <a:buNone/>
              <a:defRPr sz="2000"/>
            </a:lvl5pPr>
            <a:lvl6pPr marL="5143500" indent="0">
              <a:buNone/>
              <a:defRPr sz="2000"/>
            </a:lvl6pPr>
            <a:lvl7pPr marL="6172200" indent="0">
              <a:buNone/>
              <a:defRPr sz="2000"/>
            </a:lvl7pPr>
            <a:lvl8pPr marL="7200900" indent="0">
              <a:buNone/>
              <a:defRPr sz="2000"/>
            </a:lvl8pPr>
            <a:lvl9pPr marL="8229600" indent="0">
              <a:buNone/>
              <a:defRPr sz="20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77D4E-C74E-41B7-8EC3-42E969CCBCCC}" type="datetimeFigureOut">
              <a:rPr lang="da-DK" smtClean="0"/>
              <a:t>29-01-2018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50C9-57FD-4BEF-A576-945C40A70B5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62829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900113" y="720925"/>
            <a:ext cx="16202025" cy="3000375"/>
          </a:xfrm>
          <a:prstGeom prst="rect">
            <a:avLst/>
          </a:prstGeom>
        </p:spPr>
        <p:txBody>
          <a:bodyPr vert="horz" lIns="205740" tIns="102870" rIns="205740" bIns="102870" rtlCol="0" anchor="ctr">
            <a:normAutofit/>
          </a:bodyPr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900113" y="4200526"/>
            <a:ext cx="16202025" cy="11880653"/>
          </a:xfrm>
          <a:prstGeom prst="rect">
            <a:avLst/>
          </a:prstGeom>
        </p:spPr>
        <p:txBody>
          <a:bodyPr vert="horz" lIns="205740" tIns="102870" rIns="205740" bIns="102870" rtlCol="0">
            <a:normAutofit/>
          </a:bodyPr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900113" y="16685420"/>
            <a:ext cx="4200525" cy="958453"/>
          </a:xfrm>
          <a:prstGeom prst="rect">
            <a:avLst/>
          </a:prstGeom>
        </p:spPr>
        <p:txBody>
          <a:bodyPr vert="horz" lIns="205740" tIns="102870" rIns="205740" bIns="102870" rtlCol="0" anchor="ctr"/>
          <a:lstStyle>
            <a:lvl1pPr algn="l">
              <a:defRPr sz="2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477D4E-C74E-41B7-8EC3-42E969CCBCCC}" type="datetimeFigureOut">
              <a:rPr lang="da-DK" smtClean="0"/>
              <a:t>29-01-2018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6150769" y="16685420"/>
            <a:ext cx="5700713" cy="958453"/>
          </a:xfrm>
          <a:prstGeom prst="rect">
            <a:avLst/>
          </a:prstGeom>
        </p:spPr>
        <p:txBody>
          <a:bodyPr vert="horz" lIns="205740" tIns="102870" rIns="205740" bIns="102870" rtlCol="0" anchor="ctr"/>
          <a:lstStyle>
            <a:lvl1pPr algn="ctr">
              <a:defRPr sz="2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4"/>
          </p:nvPr>
        </p:nvSpPr>
        <p:spPr>
          <a:xfrm>
            <a:off x="12901613" y="16685420"/>
            <a:ext cx="4200525" cy="958453"/>
          </a:xfrm>
          <a:prstGeom prst="rect">
            <a:avLst/>
          </a:prstGeom>
        </p:spPr>
        <p:txBody>
          <a:bodyPr vert="horz" lIns="205740" tIns="102870" rIns="205740" bIns="102870" rtlCol="0" anchor="ctr"/>
          <a:lstStyle>
            <a:lvl1pPr algn="r">
              <a:defRPr sz="2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A650C9-57FD-4BEF-A576-945C40A70B5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0835326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057400" rtl="0" eaLnBrk="1" latinLnBrk="0" hangingPunct="1">
        <a:spcBef>
          <a:spcPct val="0"/>
        </a:spcBef>
        <a:buNone/>
        <a:defRPr sz="9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71525" indent="-771525" algn="l" defTabSz="2057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1pPr>
      <a:lvl2pPr marL="1671638" indent="-642938" algn="l" defTabSz="2057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6300" kern="1200">
          <a:solidFill>
            <a:schemeClr val="tx1"/>
          </a:solidFill>
          <a:latin typeface="+mn-lt"/>
          <a:ea typeface="+mn-ea"/>
          <a:cs typeface="+mn-cs"/>
        </a:defRPr>
      </a:lvl2pPr>
      <a:lvl3pPr marL="2571750" indent="-514350" algn="l" defTabSz="2057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450" indent="-514350" algn="l" defTabSz="2057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4500" kern="1200">
          <a:solidFill>
            <a:schemeClr val="tx1"/>
          </a:solidFill>
          <a:latin typeface="+mn-lt"/>
          <a:ea typeface="+mn-ea"/>
          <a:cs typeface="+mn-cs"/>
        </a:defRPr>
      </a:lvl4pPr>
      <a:lvl5pPr marL="4629150" indent="-514350" algn="l" defTabSz="2057400" rtl="0" eaLnBrk="1" latinLnBrk="0" hangingPunct="1">
        <a:spcBef>
          <a:spcPct val="20000"/>
        </a:spcBef>
        <a:buFont typeface="Arial" panose="020B0604020202020204" pitchFamily="34" charset="0"/>
        <a:buChar char="»"/>
        <a:defRPr sz="4500" kern="1200">
          <a:solidFill>
            <a:schemeClr val="tx1"/>
          </a:solidFill>
          <a:latin typeface="+mn-lt"/>
          <a:ea typeface="+mn-ea"/>
          <a:cs typeface="+mn-cs"/>
        </a:defRPr>
      </a:lvl5pPr>
      <a:lvl6pPr marL="5657850" indent="-514350" algn="l" defTabSz="2057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6pPr>
      <a:lvl7pPr marL="6686550" indent="-514350" algn="l" defTabSz="2057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7pPr>
      <a:lvl8pPr marL="7715250" indent="-514350" algn="l" defTabSz="2057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8pPr>
      <a:lvl9pPr marL="8743950" indent="-514350" algn="l" defTabSz="2057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2057400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1pPr>
      <a:lvl2pPr marL="1028700" algn="l" defTabSz="2057400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2pPr>
      <a:lvl3pPr marL="2057400" algn="l" defTabSz="2057400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3pPr>
      <a:lvl4pPr marL="3086100" algn="l" defTabSz="2057400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800" algn="l" defTabSz="2057400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5pPr>
      <a:lvl6pPr marL="5143500" algn="l" defTabSz="2057400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6pPr>
      <a:lvl7pPr marL="6172200" algn="l" defTabSz="2057400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7pPr>
      <a:lvl8pPr marL="7200900" algn="l" defTabSz="2057400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8pPr>
      <a:lvl9pPr marL="8229600" algn="l" defTabSz="2057400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e 4"/>
          <p:cNvGrpSpPr/>
          <p:nvPr/>
        </p:nvGrpSpPr>
        <p:grpSpPr>
          <a:xfrm>
            <a:off x="2679509" y="981954"/>
            <a:ext cx="9660859" cy="11989434"/>
            <a:chOff x="2679509" y="981954"/>
            <a:chExt cx="9660859" cy="11989434"/>
          </a:xfrm>
        </p:grpSpPr>
        <p:grpSp>
          <p:nvGrpSpPr>
            <p:cNvPr id="2" name="Gruppe 1"/>
            <p:cNvGrpSpPr/>
            <p:nvPr/>
          </p:nvGrpSpPr>
          <p:grpSpPr>
            <a:xfrm>
              <a:off x="3223259" y="981954"/>
              <a:ext cx="9117109" cy="11989434"/>
              <a:chOff x="3223259" y="890245"/>
              <a:chExt cx="9117109" cy="11989434"/>
            </a:xfrm>
          </p:grpSpPr>
          <p:sp>
            <p:nvSpPr>
              <p:cNvPr id="8" name="Tekstboks 7"/>
              <p:cNvSpPr txBox="1"/>
              <p:nvPr/>
            </p:nvSpPr>
            <p:spPr>
              <a:xfrm>
                <a:off x="4886796" y="890245"/>
                <a:ext cx="1133131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24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eated</a:t>
                </a:r>
                <a:endParaRPr lang="da-DK" sz="2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ekstboks 8"/>
              <p:cNvSpPr txBox="1"/>
              <p:nvPr/>
            </p:nvSpPr>
            <p:spPr>
              <a:xfrm>
                <a:off x="9776167" y="890245"/>
                <a:ext cx="1124026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2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da-DK" sz="2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1" name="Gruppe 20"/>
              <p:cNvGrpSpPr/>
              <p:nvPr/>
            </p:nvGrpSpPr>
            <p:grpSpPr>
              <a:xfrm>
                <a:off x="3223259" y="1008237"/>
                <a:ext cx="9117109" cy="11871442"/>
                <a:chOff x="3223259" y="1008237"/>
                <a:chExt cx="9117109" cy="11871442"/>
              </a:xfrm>
            </p:grpSpPr>
            <p:pic>
              <p:nvPicPr>
                <p:cNvPr id="4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30" t="13809" r="57344" b="13022"/>
                <a:stretch/>
              </p:blipFill>
              <p:spPr bwMode="auto">
                <a:xfrm>
                  <a:off x="7776989" y="1356702"/>
                  <a:ext cx="4563379" cy="25089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6" name="Picture 2" descr="C:\Users\blar0143\Desktop\Submittes\Supplementary figure 1.tif"/>
                <p:cNvPicPr>
                  <a:picLocks noChangeAspect="1" noChangeArrowheads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8687" b="17801"/>
                <a:stretch/>
              </p:blipFill>
              <p:spPr bwMode="auto">
                <a:xfrm>
                  <a:off x="3383279" y="6559937"/>
                  <a:ext cx="4189839" cy="6319742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7" name="Picture 2" descr="C:\Users\blar0143\Desktop\Submittes\Supplementary figure 1.tif"/>
                <p:cNvPicPr>
                  <a:picLocks noChangeAspect="1" noChangeArrowheads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94" r="44710" b="18998"/>
                <a:stretch/>
              </p:blipFill>
              <p:spPr bwMode="auto">
                <a:xfrm>
                  <a:off x="3223259" y="1008237"/>
                  <a:ext cx="4731011" cy="555512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11" name="Lige pilforbindelse 10"/>
                <p:cNvCxnSpPr/>
                <p:nvPr/>
              </p:nvCxnSpPr>
              <p:spPr>
                <a:xfrm>
                  <a:off x="11809437" y="2520405"/>
                  <a:ext cx="360040" cy="90757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1026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03" t="14387" r="57638" b="13059"/>
                <a:stretch/>
              </p:blipFill>
              <p:spPr bwMode="auto">
                <a:xfrm>
                  <a:off x="7768430" y="3931555"/>
                  <a:ext cx="4571938" cy="25092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cxnSp>
              <p:nvCxnSpPr>
                <p:cNvPr id="17" name="Lige pilforbindelse 16"/>
                <p:cNvCxnSpPr/>
                <p:nvPr/>
              </p:nvCxnSpPr>
              <p:spPr>
                <a:xfrm>
                  <a:off x="9969419" y="4968677"/>
                  <a:ext cx="360040" cy="90757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Lige pilforbindelse 17"/>
                <p:cNvCxnSpPr/>
                <p:nvPr/>
              </p:nvCxnSpPr>
              <p:spPr>
                <a:xfrm>
                  <a:off x="8425061" y="5544741"/>
                  <a:ext cx="360040" cy="90757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Lige pilforbindelse 18"/>
                <p:cNvCxnSpPr/>
                <p:nvPr/>
              </p:nvCxnSpPr>
              <p:spPr>
                <a:xfrm>
                  <a:off x="7954271" y="6048797"/>
                  <a:ext cx="360040" cy="90757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Lige pilforbindelse 19"/>
                <p:cNvCxnSpPr/>
                <p:nvPr/>
              </p:nvCxnSpPr>
              <p:spPr>
                <a:xfrm>
                  <a:off x="9681749" y="4357275"/>
                  <a:ext cx="360040" cy="90757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" name="Tekstboks 15"/>
                <p:cNvSpPr txBox="1"/>
                <p:nvPr/>
              </p:nvSpPr>
              <p:spPr>
                <a:xfrm>
                  <a:off x="7776989" y="6912893"/>
                  <a:ext cx="4563379" cy="4524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457200" indent="-457200">
                    <a:buAutoNum type="alphaUcParenR"/>
                  </a:pP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31 positive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vessel</a:t>
                  </a: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marked, by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rrow</a:t>
                  </a: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. </a:t>
                  </a:r>
                </a:p>
                <a:p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) CD68 positive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crophages</a:t>
                  </a: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, marked by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rrows</a:t>
                  </a: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. </a:t>
                  </a:r>
                </a:p>
                <a:p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) and D)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llustrate</a:t>
                  </a: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nalysis</a:t>
                  </a: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of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sson´s</a:t>
                  </a: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richrome</a:t>
                  </a: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, with a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epresentative</a:t>
                  </a: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short axis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lice</a:t>
                  </a: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C), and the mask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used</a:t>
                  </a: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for image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nalysis</a:t>
                  </a: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in Image J D). The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sson´s</a:t>
                  </a: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richrome</a:t>
                  </a: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images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re</a:t>
                  </a: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epresentative</a:t>
                  </a: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for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oth</a:t>
                  </a: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reated</a:t>
                  </a: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and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trol</a:t>
                  </a:r>
                  <a:r>
                    <a:rPr lang="da-DK" sz="2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da-DK" sz="2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nimals</a:t>
                  </a:r>
                  <a:endParaRPr lang="da-DK" sz="2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3" name="Tekstboks 2"/>
            <p:cNvSpPr txBox="1"/>
            <p:nvPr/>
          </p:nvSpPr>
          <p:spPr>
            <a:xfrm>
              <a:off x="2679509" y="1443619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22" name="Tekstboks 21"/>
            <p:cNvSpPr txBox="1"/>
            <p:nvPr/>
          </p:nvSpPr>
          <p:spPr>
            <a:xfrm>
              <a:off x="2679509" y="3987501"/>
              <a:ext cx="35618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da-DK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kstboks 22"/>
            <p:cNvSpPr txBox="1"/>
            <p:nvPr/>
          </p:nvSpPr>
          <p:spPr>
            <a:xfrm>
              <a:off x="2679509" y="7004602"/>
              <a:ext cx="35618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24" name="Tekstboks 23"/>
            <p:cNvSpPr txBox="1"/>
            <p:nvPr/>
          </p:nvSpPr>
          <p:spPr>
            <a:xfrm>
              <a:off x="2679509" y="9811517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da-DK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3748445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2418b5e2-0881-45b5-a89c-4ad3fb5e93c4"/>
  <p:tag name="_AMO_REPORTCONTROLSVISIBLE" val="Empty"/>
</p:tagLst>
</file>

<file path=ppt/theme/theme1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67</Words>
  <Application>Microsoft Office PowerPoint</Application>
  <PresentationFormat>Brugerdefineret</PresentationFormat>
  <Paragraphs>9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Diastitler</vt:lpstr>
      </vt:variant>
      <vt:variant>
        <vt:i4>1</vt:i4>
      </vt:variant>
    </vt:vector>
  </HeadingPairs>
  <TitlesOfParts>
    <vt:vector size="2" baseType="lpstr">
      <vt:lpstr>Kontortema</vt:lpstr>
      <vt:lpstr>PowerPoint-præsentation</vt:lpstr>
    </vt:vector>
  </TitlesOfParts>
  <Company>Region Hovedstad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Bjarke Follin Larsen</dc:creator>
  <cp:lastModifiedBy>Bjarke Follin Larsen</cp:lastModifiedBy>
  <cp:revision>7</cp:revision>
  <dcterms:created xsi:type="dcterms:W3CDTF">2018-01-05T13:27:39Z</dcterms:created>
  <dcterms:modified xsi:type="dcterms:W3CDTF">2018-01-29T07:44:01Z</dcterms:modified>
</cp:coreProperties>
</file>